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5DC4D2-0964-4335-B568-389955AD84B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6AFBD0-138A-414E-B8B5-BA9993000D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9FE5E5-1D19-4A39-8CC8-6AD448A92C5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236C23-0BA1-46A4-9D65-D0925C06B8B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B91A3F-16B0-43EB-9669-E39F57C262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CD9EBA-4FED-4FDB-8E7E-D44372DD37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BC4996-4414-495E-9EE2-CBE8F0FC4A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F148D8-4C4A-4729-9E37-67E6D81F0C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474CA1-7BA7-47C1-B259-137C1985D80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2B4547-A7B5-4355-AA8D-00099C96F9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BA69D2-A53C-45E7-AA29-CED77B4E57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D6BC1D-5AC2-45B3-BC00-72681BC8F0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5BF40A6-DF61-44D5-A961-17A8BDD5EA85}" type="slidenum"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6"/>
          <p:cNvSpPr/>
          <p:nvPr/>
        </p:nvSpPr>
        <p:spPr>
          <a:xfrm>
            <a:off x="1355760" y="450720"/>
            <a:ext cx="59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7"/>
          <p:cNvSpPr/>
          <p:nvPr/>
        </p:nvSpPr>
        <p:spPr>
          <a:xfrm>
            <a:off x="1371600" y="3809880"/>
            <a:ext cx="59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9"/>
          <p:cNvSpPr/>
          <p:nvPr/>
        </p:nvSpPr>
        <p:spPr>
          <a:xfrm>
            <a:off x="3894120" y="12952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PC-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10"/>
          <p:cNvSpPr/>
          <p:nvPr/>
        </p:nvSpPr>
        <p:spPr>
          <a:xfrm>
            <a:off x="3524400" y="2830680"/>
            <a:ext cx="1218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-  10 25 50 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12"/>
          <p:cNvSpPr/>
          <p:nvPr/>
        </p:nvSpPr>
        <p:spPr>
          <a:xfrm>
            <a:off x="2549520" y="2819520"/>
            <a:ext cx="990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OA (</a:t>
            </a:r>
            <a:r>
              <a:rPr b="1" lang="el-GR" sz="1200" spc="-1" strike="noStrike">
                <a:solidFill>
                  <a:srgbClr val="000000"/>
                </a:solidFill>
                <a:latin typeface="Arial"/>
              </a:rPr>
              <a:t>μ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g/mL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13"/>
          <p:cNvSpPr/>
          <p:nvPr/>
        </p:nvSpPr>
        <p:spPr>
          <a:xfrm>
            <a:off x="4937040" y="1249200"/>
            <a:ext cx="1219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MCF-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4"/>
          <p:cNvSpPr/>
          <p:nvPr/>
        </p:nvSpPr>
        <p:spPr>
          <a:xfrm>
            <a:off x="4884840" y="2827440"/>
            <a:ext cx="129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-  10 25 50 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20"/>
          <p:cNvSpPr/>
          <p:nvPr/>
        </p:nvSpPr>
        <p:spPr>
          <a:xfrm>
            <a:off x="3314880" y="4038480"/>
            <a:ext cx="76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PC-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21"/>
          <p:cNvSpPr/>
          <p:nvPr/>
        </p:nvSpPr>
        <p:spPr>
          <a:xfrm>
            <a:off x="2998800" y="5640480"/>
            <a:ext cx="1863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.5  1   2   3   6  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22"/>
          <p:cNvSpPr/>
          <p:nvPr/>
        </p:nvSpPr>
        <p:spPr>
          <a:xfrm rot="3600000">
            <a:off x="2723400" y="5938920"/>
            <a:ext cx="723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23"/>
          <p:cNvSpPr/>
          <p:nvPr/>
        </p:nvSpPr>
        <p:spPr>
          <a:xfrm>
            <a:off x="3278160" y="5918040"/>
            <a:ext cx="13114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24"/>
          <p:cNvSpPr/>
          <p:nvPr/>
        </p:nvSpPr>
        <p:spPr>
          <a:xfrm>
            <a:off x="3295800" y="5918040"/>
            <a:ext cx="129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100 </a:t>
            </a:r>
            <a:r>
              <a:rPr b="1" lang="el-GR" sz="1200" spc="-1" strike="noStrike">
                <a:solidFill>
                  <a:srgbClr val="000000"/>
                </a:solidFill>
                <a:latin typeface="Arial"/>
              </a:rPr>
              <a:t>μ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g/mL O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25"/>
          <p:cNvSpPr/>
          <p:nvPr/>
        </p:nvSpPr>
        <p:spPr>
          <a:xfrm>
            <a:off x="2860560" y="5641920"/>
            <a:ext cx="43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27"/>
          <p:cNvSpPr/>
          <p:nvPr/>
        </p:nvSpPr>
        <p:spPr>
          <a:xfrm>
            <a:off x="5197320" y="404028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MCF-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28"/>
          <p:cNvSpPr/>
          <p:nvPr/>
        </p:nvSpPr>
        <p:spPr>
          <a:xfrm>
            <a:off x="4881600" y="5641920"/>
            <a:ext cx="1863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0.5  1   2   3   6  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29"/>
          <p:cNvSpPr/>
          <p:nvPr/>
        </p:nvSpPr>
        <p:spPr>
          <a:xfrm rot="3600000">
            <a:off x="4606200" y="5940360"/>
            <a:ext cx="723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30"/>
          <p:cNvSpPr/>
          <p:nvPr/>
        </p:nvSpPr>
        <p:spPr>
          <a:xfrm>
            <a:off x="5160960" y="5918040"/>
            <a:ext cx="13111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31"/>
          <p:cNvSpPr/>
          <p:nvPr/>
        </p:nvSpPr>
        <p:spPr>
          <a:xfrm>
            <a:off x="5197320" y="5918040"/>
            <a:ext cx="1298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100 </a:t>
            </a:r>
            <a:r>
              <a:rPr b="1" lang="el-GR" sz="1200" spc="-1" strike="noStrike">
                <a:solidFill>
                  <a:srgbClr val="000000"/>
                </a:solidFill>
                <a:latin typeface="Arial"/>
              </a:rPr>
              <a:t>μ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g/mL O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32"/>
          <p:cNvSpPr/>
          <p:nvPr/>
        </p:nvSpPr>
        <p:spPr>
          <a:xfrm>
            <a:off x="4743360" y="5643720"/>
            <a:ext cx="43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34"/>
          <p:cNvSpPr/>
          <p:nvPr/>
        </p:nvSpPr>
        <p:spPr>
          <a:xfrm>
            <a:off x="2076480" y="5638680"/>
            <a:ext cx="99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time (hr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36"/>
          <p:cNvSpPr/>
          <p:nvPr/>
        </p:nvSpPr>
        <p:spPr>
          <a:xfrm rot="16200000">
            <a:off x="2184120" y="1842480"/>
            <a:ext cx="167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Relative PK activit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2" name="Object 37"/>
          <p:cNvGraphicFramePr/>
          <p:nvPr/>
        </p:nvGraphicFramePr>
        <p:xfrm>
          <a:off x="3200400" y="1143000"/>
          <a:ext cx="3040200" cy="18669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63" name="Object 37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200400" y="1143000"/>
                    <a:ext cx="3040200" cy="1866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4" name="Object 38"/>
          <p:cNvGraphicFramePr/>
          <p:nvPr/>
        </p:nvGraphicFramePr>
        <p:xfrm>
          <a:off x="2606760" y="3962520"/>
          <a:ext cx="4137120" cy="187488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65" name="Object 38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606760" y="3962520"/>
                    <a:ext cx="4137120" cy="1874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6" name="Text Box 39"/>
          <p:cNvSpPr/>
          <p:nvPr/>
        </p:nvSpPr>
        <p:spPr>
          <a:xfrm rot="16200000">
            <a:off x="1586160" y="4662360"/>
            <a:ext cx="167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Relative PK activit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40"/>
          <p:cNvSpPr/>
          <p:nvPr/>
        </p:nvSpPr>
        <p:spPr>
          <a:xfrm>
            <a:off x="4194000" y="1760400"/>
            <a:ext cx="389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41"/>
          <p:cNvSpPr/>
          <p:nvPr/>
        </p:nvSpPr>
        <p:spPr>
          <a:xfrm>
            <a:off x="4419720" y="1447920"/>
            <a:ext cx="38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42"/>
          <p:cNvSpPr/>
          <p:nvPr/>
        </p:nvSpPr>
        <p:spPr>
          <a:xfrm>
            <a:off x="5365800" y="1820880"/>
            <a:ext cx="30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45"/>
          <p:cNvSpPr/>
          <p:nvPr/>
        </p:nvSpPr>
        <p:spPr>
          <a:xfrm>
            <a:off x="5799240" y="1287360"/>
            <a:ext cx="38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46"/>
          <p:cNvSpPr/>
          <p:nvPr/>
        </p:nvSpPr>
        <p:spPr>
          <a:xfrm>
            <a:off x="5562720" y="1752480"/>
            <a:ext cx="38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47"/>
          <p:cNvSpPr/>
          <p:nvPr/>
        </p:nvSpPr>
        <p:spPr>
          <a:xfrm>
            <a:off x="3914640" y="4782960"/>
            <a:ext cx="30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48"/>
          <p:cNvSpPr/>
          <p:nvPr/>
        </p:nvSpPr>
        <p:spPr>
          <a:xfrm>
            <a:off x="4356000" y="4051440"/>
            <a:ext cx="381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49"/>
          <p:cNvSpPr/>
          <p:nvPr/>
        </p:nvSpPr>
        <p:spPr>
          <a:xfrm>
            <a:off x="4119480" y="4270320"/>
            <a:ext cx="381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50"/>
          <p:cNvSpPr/>
          <p:nvPr/>
        </p:nvSpPr>
        <p:spPr>
          <a:xfrm>
            <a:off x="5794200" y="4605480"/>
            <a:ext cx="39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51"/>
          <p:cNvSpPr/>
          <p:nvPr/>
        </p:nvSpPr>
        <p:spPr>
          <a:xfrm>
            <a:off x="6302520" y="4159080"/>
            <a:ext cx="38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52"/>
          <p:cNvSpPr/>
          <p:nvPr/>
        </p:nvSpPr>
        <p:spPr>
          <a:xfrm>
            <a:off x="6046920" y="4214880"/>
            <a:ext cx="38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2-26T13:06:17Z</dcterms:created>
  <dc:creator>Jia</dc:creator>
  <dc:description/>
  <dc:language>en-US</dc:language>
  <cp:lastModifiedBy>dadaliujia</cp:lastModifiedBy>
  <dcterms:modified xsi:type="dcterms:W3CDTF">2014-02-20T10:18:57Z</dcterms:modified>
  <cp:revision>21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